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1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DD01AB-9C3C-4244-8847-9C581E4D8042}" v="6" dt="2023-05-27T13:31:42.529"/>
    <p1510:client id="{55A25D15-C3B9-4D16-A5C7-0D0594DC4503}" v="164" dt="2023-05-27T13:53:19.209"/>
    <p1510:client id="{5B98C2CB-2012-4A76-861D-13E23323019B}" v="90" dt="2023-05-27T13:40:04.0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4" d="100"/>
          <a:sy n="84" d="100"/>
        </p:scale>
        <p:origin x="9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loah Chamoun" userId="73675ff5-06fe-4c34-b56c-c1c1251fe626" providerId="ADAL" clId="{5B98C2CB-2012-4A76-861D-13E23323019B}"/>
    <pc:docChg chg="custSel modSld">
      <pc:chgData name="Loloah Chamoun" userId="73675ff5-06fe-4c34-b56c-c1c1251fe626" providerId="ADAL" clId="{5B98C2CB-2012-4A76-861D-13E23323019B}" dt="2023-05-27T13:40:04.063" v="105" actId="403"/>
      <pc:docMkLst>
        <pc:docMk/>
      </pc:docMkLst>
      <pc:sldChg chg="addSp delSp modSp mod">
        <pc:chgData name="Loloah Chamoun" userId="73675ff5-06fe-4c34-b56c-c1c1251fe626" providerId="ADAL" clId="{5B98C2CB-2012-4A76-861D-13E23323019B}" dt="2023-05-27T13:40:04.063" v="105" actId="403"/>
        <pc:sldMkLst>
          <pc:docMk/>
          <pc:sldMk cId="3144706318" sldId="257"/>
        </pc:sldMkLst>
        <pc:spChg chg="add del mod">
          <ac:chgData name="Loloah Chamoun" userId="73675ff5-06fe-4c34-b56c-c1c1251fe626" providerId="ADAL" clId="{5B98C2CB-2012-4A76-861D-13E23323019B}" dt="2023-05-27T13:33:53.736" v="2" actId="1957"/>
          <ac:spMkLst>
            <pc:docMk/>
            <pc:sldMk cId="3144706318" sldId="257"/>
            <ac:spMk id="4" creationId="{6555E898-A6D4-EB9D-F430-99B70195C498}"/>
          </ac:spMkLst>
        </pc:spChg>
        <pc:graphicFrameChg chg="del">
          <ac:chgData name="Loloah Chamoun" userId="73675ff5-06fe-4c34-b56c-c1c1251fe626" providerId="ADAL" clId="{5B98C2CB-2012-4A76-861D-13E23323019B}" dt="2023-05-27T13:33:14.752" v="0" actId="478"/>
          <ac:graphicFrameMkLst>
            <pc:docMk/>
            <pc:sldMk cId="3144706318" sldId="257"/>
            <ac:graphicFrameMk id="6" creationId="{82390A93-FC34-3102-3F9C-4359B4DF0AFE}"/>
          </ac:graphicFrameMkLst>
        </pc:graphicFrameChg>
        <pc:graphicFrameChg chg="add mod">
          <ac:chgData name="Loloah Chamoun" userId="73675ff5-06fe-4c34-b56c-c1c1251fe626" providerId="ADAL" clId="{5B98C2CB-2012-4A76-861D-13E23323019B}" dt="2023-05-27T13:40:04.063" v="105" actId="403"/>
          <ac:graphicFrameMkLst>
            <pc:docMk/>
            <pc:sldMk cId="3144706318" sldId="257"/>
            <ac:graphicFrameMk id="8" creationId="{CFF9C873-9ABA-B9C1-4674-0B4D715D9001}"/>
          </ac:graphicFrameMkLst>
        </pc:graphicFrameChg>
      </pc:sldChg>
    </pc:docChg>
  </pc:docChgLst>
  <pc:docChgLst>
    <pc:chgData name="Loloah Chamoun" userId="73675ff5-06fe-4c34-b56c-c1c1251fe626" providerId="ADAL" clId="{43DD01AB-9C3C-4244-8847-9C581E4D8042}"/>
    <pc:docChg chg="modSld">
      <pc:chgData name="Loloah Chamoun" userId="73675ff5-06fe-4c34-b56c-c1c1251fe626" providerId="ADAL" clId="{43DD01AB-9C3C-4244-8847-9C581E4D8042}" dt="2023-05-27T13:31:42.529" v="5" actId="403"/>
      <pc:docMkLst>
        <pc:docMk/>
      </pc:docMkLst>
      <pc:sldChg chg="modSp mod">
        <pc:chgData name="Loloah Chamoun" userId="73675ff5-06fe-4c34-b56c-c1c1251fe626" providerId="ADAL" clId="{43DD01AB-9C3C-4244-8847-9C581E4D8042}" dt="2023-05-27T13:31:42.529" v="5" actId="403"/>
        <pc:sldMkLst>
          <pc:docMk/>
          <pc:sldMk cId="3144706318" sldId="257"/>
        </pc:sldMkLst>
        <pc:graphicFrameChg chg="mod">
          <ac:chgData name="Loloah Chamoun" userId="73675ff5-06fe-4c34-b56c-c1c1251fe626" providerId="ADAL" clId="{43DD01AB-9C3C-4244-8847-9C581E4D8042}" dt="2023-05-27T13:31:42.529" v="5" actId="403"/>
          <ac:graphicFrameMkLst>
            <pc:docMk/>
            <pc:sldMk cId="3144706318" sldId="257"/>
            <ac:graphicFrameMk id="6" creationId="{82390A93-FC34-3102-3F9C-4359B4DF0AFE}"/>
          </ac:graphicFrameMkLst>
        </pc:graphicFrameChg>
      </pc:sldChg>
    </pc:docChg>
  </pc:docChgLst>
  <pc:docChgLst>
    <pc:chgData name="Loloah Chamoun" userId="73675ff5-06fe-4c34-b56c-c1c1251fe626" providerId="ADAL" clId="{55A25D15-C3B9-4D16-A5C7-0D0594DC4503}"/>
    <pc:docChg chg="custSel addSld delSld modSld sldOrd">
      <pc:chgData name="Loloah Chamoun" userId="73675ff5-06fe-4c34-b56c-c1c1251fe626" providerId="ADAL" clId="{55A25D15-C3B9-4D16-A5C7-0D0594DC4503}" dt="2023-05-27T13:53:51.498" v="482" actId="27918"/>
      <pc:docMkLst>
        <pc:docMk/>
      </pc:docMkLst>
      <pc:sldChg chg="addSp delSp modSp mod ord">
        <pc:chgData name="Loloah Chamoun" userId="73675ff5-06fe-4c34-b56c-c1c1251fe626" providerId="ADAL" clId="{55A25D15-C3B9-4D16-A5C7-0D0594DC4503}" dt="2023-05-27T13:50:36.671" v="321" actId="27918"/>
        <pc:sldMkLst>
          <pc:docMk/>
          <pc:sldMk cId="3144706318" sldId="257"/>
        </pc:sldMkLst>
        <pc:spChg chg="mod">
          <ac:chgData name="Loloah Chamoun" userId="73675ff5-06fe-4c34-b56c-c1c1251fe626" providerId="ADAL" clId="{55A25D15-C3B9-4D16-A5C7-0D0594DC4503}" dt="2023-05-27T13:50:02.512" v="312" actId="6549"/>
          <ac:spMkLst>
            <pc:docMk/>
            <pc:sldMk cId="3144706318" sldId="257"/>
            <ac:spMk id="2" creationId="{C33B671A-2340-2D12-AA27-65EF0E8D607C}"/>
          </ac:spMkLst>
        </pc:spChg>
        <pc:spChg chg="add del mod">
          <ac:chgData name="Loloah Chamoun" userId="73675ff5-06fe-4c34-b56c-c1c1251fe626" providerId="ADAL" clId="{55A25D15-C3B9-4D16-A5C7-0D0594DC4503}" dt="2023-05-27T13:42:44.470" v="73" actId="1957"/>
          <ac:spMkLst>
            <pc:docMk/>
            <pc:sldMk cId="3144706318" sldId="257"/>
            <ac:spMk id="4" creationId="{7C2AFC79-BF93-8CE8-1C38-F51E46149795}"/>
          </ac:spMkLst>
        </pc:spChg>
        <pc:spChg chg="add del mod">
          <ac:chgData name="Loloah Chamoun" userId="73675ff5-06fe-4c34-b56c-c1c1251fe626" providerId="ADAL" clId="{55A25D15-C3B9-4D16-A5C7-0D0594DC4503}" dt="2023-05-27T13:47:10.603" v="176" actId="1957"/>
          <ac:spMkLst>
            <pc:docMk/>
            <pc:sldMk cId="3144706318" sldId="257"/>
            <ac:spMk id="11" creationId="{BA7F6406-3CEE-88E1-5D47-65AA49B5A66B}"/>
          </ac:spMkLst>
        </pc:spChg>
        <pc:graphicFrameChg chg="add del mod">
          <ac:chgData name="Loloah Chamoun" userId="73675ff5-06fe-4c34-b56c-c1c1251fe626" providerId="ADAL" clId="{55A25D15-C3B9-4D16-A5C7-0D0594DC4503}" dt="2023-05-27T13:46:59.662" v="174" actId="478"/>
          <ac:graphicFrameMkLst>
            <pc:docMk/>
            <pc:sldMk cId="3144706318" sldId="257"/>
            <ac:graphicFrameMk id="7" creationId="{4D9C6703-6F0F-9726-3CF8-0439BFEB53DB}"/>
          </ac:graphicFrameMkLst>
        </pc:graphicFrameChg>
        <pc:graphicFrameChg chg="del">
          <ac:chgData name="Loloah Chamoun" userId="73675ff5-06fe-4c34-b56c-c1c1251fe626" providerId="ADAL" clId="{55A25D15-C3B9-4D16-A5C7-0D0594DC4503}" dt="2023-05-27T13:41:27.574" v="71" actId="478"/>
          <ac:graphicFrameMkLst>
            <pc:docMk/>
            <pc:sldMk cId="3144706318" sldId="257"/>
            <ac:graphicFrameMk id="8" creationId="{CFF9C873-9ABA-B9C1-4674-0B4D715D9001}"/>
          </ac:graphicFrameMkLst>
        </pc:graphicFrameChg>
        <pc:graphicFrameChg chg="add del mod">
          <ac:chgData name="Loloah Chamoun" userId="73675ff5-06fe-4c34-b56c-c1c1251fe626" providerId="ADAL" clId="{55A25D15-C3B9-4D16-A5C7-0D0594DC4503}" dt="2023-05-27T13:46:58.479" v="173" actId="478"/>
          <ac:graphicFrameMkLst>
            <pc:docMk/>
            <pc:sldMk cId="3144706318" sldId="257"/>
            <ac:graphicFrameMk id="9" creationId="{66A9251C-7013-AC33-C322-A93609F8C338}"/>
          </ac:graphicFrameMkLst>
        </pc:graphicFrameChg>
        <pc:graphicFrameChg chg="add mod">
          <ac:chgData name="Loloah Chamoun" userId="73675ff5-06fe-4c34-b56c-c1c1251fe626" providerId="ADAL" clId="{55A25D15-C3B9-4D16-A5C7-0D0594DC4503}" dt="2023-05-27T13:49:10.871" v="272" actId="2711"/>
          <ac:graphicFrameMkLst>
            <pc:docMk/>
            <pc:sldMk cId="3144706318" sldId="257"/>
            <ac:graphicFrameMk id="14" creationId="{D2739974-0426-6AAC-0403-69F7BB7B7C00}"/>
          </ac:graphicFrameMkLst>
        </pc:graphicFrameChg>
      </pc:sldChg>
      <pc:sldChg chg="new del">
        <pc:chgData name="Loloah Chamoun" userId="73675ff5-06fe-4c34-b56c-c1c1251fe626" providerId="ADAL" clId="{55A25D15-C3B9-4D16-A5C7-0D0594DC4503}" dt="2023-05-27T13:49:18.436" v="274" actId="47"/>
        <pc:sldMkLst>
          <pc:docMk/>
          <pc:sldMk cId="3783948971" sldId="258"/>
        </pc:sldMkLst>
      </pc:sldChg>
      <pc:sldChg chg="new del">
        <pc:chgData name="Loloah Chamoun" userId="73675ff5-06fe-4c34-b56c-c1c1251fe626" providerId="ADAL" clId="{55A25D15-C3B9-4D16-A5C7-0D0594DC4503}" dt="2023-05-27T13:49:19.620" v="275" actId="47"/>
        <pc:sldMkLst>
          <pc:docMk/>
          <pc:sldMk cId="914762583" sldId="259"/>
        </pc:sldMkLst>
      </pc:sldChg>
      <pc:sldChg chg="modSp add mod">
        <pc:chgData name="Loloah Chamoun" userId="73675ff5-06fe-4c34-b56c-c1c1251fe626" providerId="ADAL" clId="{55A25D15-C3B9-4D16-A5C7-0D0594DC4503}" dt="2023-05-27T13:49:55.153" v="292" actId="20577"/>
        <pc:sldMkLst>
          <pc:docMk/>
          <pc:sldMk cId="1297701002" sldId="260"/>
        </pc:sldMkLst>
        <pc:spChg chg="mod">
          <ac:chgData name="Loloah Chamoun" userId="73675ff5-06fe-4c34-b56c-c1c1251fe626" providerId="ADAL" clId="{55A25D15-C3B9-4D16-A5C7-0D0594DC4503}" dt="2023-05-27T13:49:55.153" v="292" actId="20577"/>
          <ac:spMkLst>
            <pc:docMk/>
            <pc:sldMk cId="1297701002" sldId="260"/>
            <ac:spMk id="2" creationId="{C33B671A-2340-2D12-AA27-65EF0E8D607C}"/>
          </ac:spMkLst>
        </pc:spChg>
      </pc:sldChg>
      <pc:sldChg chg="addSp delSp modSp add mod">
        <pc:chgData name="Loloah Chamoun" userId="73675ff5-06fe-4c34-b56c-c1c1251fe626" providerId="ADAL" clId="{55A25D15-C3B9-4D16-A5C7-0D0594DC4503}" dt="2023-05-27T13:52:45.368" v="443"/>
        <pc:sldMkLst>
          <pc:docMk/>
          <pc:sldMk cId="699747373" sldId="261"/>
        </pc:sldMkLst>
        <pc:spChg chg="mod">
          <ac:chgData name="Loloah Chamoun" userId="73675ff5-06fe-4c34-b56c-c1c1251fe626" providerId="ADAL" clId="{55A25D15-C3B9-4D16-A5C7-0D0594DC4503}" dt="2023-05-27T13:51:02.386" v="336" actId="20577"/>
          <ac:spMkLst>
            <pc:docMk/>
            <pc:sldMk cId="699747373" sldId="261"/>
            <ac:spMk id="2" creationId="{C33B671A-2340-2D12-AA27-65EF0E8D607C}"/>
          </ac:spMkLst>
        </pc:spChg>
        <pc:spChg chg="add del mod">
          <ac:chgData name="Loloah Chamoun" userId="73675ff5-06fe-4c34-b56c-c1c1251fe626" providerId="ADAL" clId="{55A25D15-C3B9-4D16-A5C7-0D0594DC4503}" dt="2023-05-27T13:51:05.762" v="338" actId="1957"/>
          <ac:spMkLst>
            <pc:docMk/>
            <pc:sldMk cId="699747373" sldId="261"/>
            <ac:spMk id="4" creationId="{3F1873E8-F47F-B30B-1DE1-E004F4BC10E6}"/>
          </ac:spMkLst>
        </pc:spChg>
        <pc:graphicFrameChg chg="add mod">
          <ac:chgData name="Loloah Chamoun" userId="73675ff5-06fe-4c34-b56c-c1c1251fe626" providerId="ADAL" clId="{55A25D15-C3B9-4D16-A5C7-0D0594DC4503}" dt="2023-05-27T13:52:45.368" v="443"/>
          <ac:graphicFrameMkLst>
            <pc:docMk/>
            <pc:sldMk cId="699747373" sldId="261"/>
            <ac:graphicFrameMk id="7" creationId="{154C8882-22D4-7777-EEEE-4D3AB0BE427D}"/>
          </ac:graphicFrameMkLst>
        </pc:graphicFrameChg>
        <pc:graphicFrameChg chg="del">
          <ac:chgData name="Loloah Chamoun" userId="73675ff5-06fe-4c34-b56c-c1c1251fe626" providerId="ADAL" clId="{55A25D15-C3B9-4D16-A5C7-0D0594DC4503}" dt="2023-05-27T13:50:48.204" v="323" actId="478"/>
          <ac:graphicFrameMkLst>
            <pc:docMk/>
            <pc:sldMk cId="699747373" sldId="261"/>
            <ac:graphicFrameMk id="14" creationId="{D2739974-0426-6AAC-0403-69F7BB7B7C00}"/>
          </ac:graphicFrameMkLst>
        </pc:graphicFrameChg>
      </pc:sldChg>
      <pc:sldChg chg="modSp add mod">
        <pc:chgData name="Loloah Chamoun" userId="73675ff5-06fe-4c34-b56c-c1c1251fe626" providerId="ADAL" clId="{55A25D15-C3B9-4D16-A5C7-0D0594DC4503}" dt="2023-05-27T13:53:51.498" v="482" actId="27918"/>
        <pc:sldMkLst>
          <pc:docMk/>
          <pc:sldMk cId="560839062" sldId="262"/>
        </pc:sldMkLst>
        <pc:spChg chg="mod">
          <ac:chgData name="Loloah Chamoun" userId="73675ff5-06fe-4c34-b56c-c1c1251fe626" providerId="ADAL" clId="{55A25D15-C3B9-4D16-A5C7-0D0594DC4503}" dt="2023-05-27T13:53:00.654" v="467" actId="20577"/>
          <ac:spMkLst>
            <pc:docMk/>
            <pc:sldMk cId="560839062" sldId="262"/>
            <ac:spMk id="2" creationId="{C33B671A-2340-2D12-AA27-65EF0E8D607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trongly like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1.1</c:v>
                </c:pt>
                <c:pt idx="1">
                  <c:v>3.5</c:v>
                </c:pt>
                <c:pt idx="2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0D-46C8-AEA4-F13F6FCBAAA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k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61.1</c:v>
                </c:pt>
                <c:pt idx="1">
                  <c:v>63.2</c:v>
                </c:pt>
                <c:pt idx="2">
                  <c:v>6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0D-46C8-AEA4-F13F6FCBAAA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either like nor dislike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7.4</c:v>
                </c:pt>
                <c:pt idx="1">
                  <c:v>8.8000000000000007</c:v>
                </c:pt>
                <c:pt idx="2">
                  <c:v>9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0D-46C8-AEA4-F13F6FCBAAA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islike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18.5</c:v>
                </c:pt>
                <c:pt idx="1">
                  <c:v>24.6</c:v>
                </c:pt>
                <c:pt idx="2">
                  <c:v>24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E0D-46C8-AEA4-F13F6FCBAAA9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trongly dislike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1.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0D-46C8-AEA4-F13F6FCBAAA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770557344"/>
        <c:axId val="1770557824"/>
      </c:barChart>
      <c:catAx>
        <c:axId val="1770557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Tomato paste samples com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70557824"/>
        <c:crosses val="autoZero"/>
        <c:auto val="1"/>
        <c:lblAlgn val="ctr"/>
        <c:lblOffset val="100"/>
        <c:noMultiLvlLbl val="0"/>
      </c:catAx>
      <c:valAx>
        <c:axId val="1770557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Proportion of participa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705573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trongly like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5.6</c:v>
                </c:pt>
                <c:pt idx="1">
                  <c:v>1.8</c:v>
                </c:pt>
                <c:pt idx="2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0D-46C8-AEA4-F13F6FCBAAA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k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63</c:v>
                </c:pt>
                <c:pt idx="1">
                  <c:v>82.5</c:v>
                </c:pt>
                <c:pt idx="2">
                  <c:v>68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0D-46C8-AEA4-F13F6FCBAAA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either like nor dislike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3.7</c:v>
                </c:pt>
                <c:pt idx="1">
                  <c:v>5.3</c:v>
                </c:pt>
                <c:pt idx="2">
                  <c:v>1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0D-46C8-AEA4-F13F6FCBAAA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islike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27</c:v>
                </c:pt>
                <c:pt idx="1">
                  <c:v>10.5</c:v>
                </c:pt>
                <c:pt idx="2">
                  <c:v>1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E0D-46C8-AEA4-F13F6FCBAAA9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trongly dislike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0D-46C8-AEA4-F13F6FCBAAA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770557344"/>
        <c:axId val="1770557824"/>
      </c:barChart>
      <c:catAx>
        <c:axId val="1770557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Tomato paste samples com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70557824"/>
        <c:crosses val="autoZero"/>
        <c:auto val="1"/>
        <c:lblAlgn val="ctr"/>
        <c:lblOffset val="100"/>
        <c:noMultiLvlLbl val="0"/>
      </c:catAx>
      <c:valAx>
        <c:axId val="1770557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Proportion of participa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705573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trongly like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7.4</c:v>
                </c:pt>
                <c:pt idx="1">
                  <c:v>5.3</c:v>
                </c:pt>
                <c:pt idx="2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15-4198-A21E-DF76D0077DE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k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63</c:v>
                </c:pt>
                <c:pt idx="1">
                  <c:v>66.7</c:v>
                </c:pt>
                <c:pt idx="2">
                  <c:v>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15-4198-A21E-DF76D0077DE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either like nor dislike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7.4</c:v>
                </c:pt>
                <c:pt idx="1">
                  <c:v>7</c:v>
                </c:pt>
                <c:pt idx="2">
                  <c:v>9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F15-4198-A21E-DF76D0077DE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islike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20.399999999999999</c:v>
                </c:pt>
                <c:pt idx="1">
                  <c:v>21.1</c:v>
                </c:pt>
                <c:pt idx="2">
                  <c:v>2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F15-4198-A21E-DF76D0077DEA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trongly dislike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1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F15-4198-A21E-DF76D0077DE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2960576"/>
        <c:axId val="121461615"/>
      </c:barChart>
      <c:catAx>
        <c:axId val="2960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Tomato paste samples com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1461615"/>
        <c:crosses val="autoZero"/>
        <c:auto val="1"/>
        <c:lblAlgn val="ctr"/>
        <c:lblOffset val="100"/>
        <c:noMultiLvlLbl val="0"/>
      </c:catAx>
      <c:valAx>
        <c:axId val="1214616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Proportion of participa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60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trongly like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1.1</c:v>
                </c:pt>
                <c:pt idx="1">
                  <c:v>3.5</c:v>
                </c:pt>
                <c:pt idx="2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15-4198-A21E-DF76D0077DE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Like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63</c:v>
                </c:pt>
                <c:pt idx="1">
                  <c:v>70.2</c:v>
                </c:pt>
                <c:pt idx="2">
                  <c:v>6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15-4198-A21E-DF76D0077DE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either like nor dislike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5.6</c:v>
                </c:pt>
                <c:pt idx="1">
                  <c:v>5.3</c:v>
                </c:pt>
                <c:pt idx="2">
                  <c:v>7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F15-4198-A21E-DF76D0077DE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Dislike</c:v>
                </c:pt>
              </c:strCache>
            </c:strRef>
          </c:tx>
          <c:spPr>
            <a:solidFill>
              <a:schemeClr val="dk1">
                <a:tint val="9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18.5</c:v>
                </c:pt>
                <c:pt idx="1">
                  <c:v>21.1</c:v>
                </c:pt>
                <c:pt idx="2">
                  <c:v>20.3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F15-4198-A21E-DF76D0077DEA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trongly dislike</c:v>
                </c:pt>
              </c:strCache>
            </c:strRef>
          </c:tx>
          <c:spPr>
            <a:solidFill>
              <a:schemeClr val="dk1">
                <a:tint val="3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PWL/TP 30%</c:v>
                </c:pt>
                <c:pt idx="1">
                  <c:v>PWL/TP 15%</c:v>
                </c:pt>
                <c:pt idx="2">
                  <c:v>PWL/TP 8%</c:v>
                </c:pt>
              </c:strCache>
            </c:strRef>
          </c:cat>
          <c:val>
            <c:numRef>
              <c:f>Sheet1!$F$2:$F$4</c:f>
              <c:numCache>
                <c:formatCode>General</c:formatCode>
                <c:ptCount val="3"/>
                <c:pt idx="0">
                  <c:v>1.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F15-4198-A21E-DF76D0077DE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2960576"/>
        <c:axId val="121461615"/>
      </c:barChart>
      <c:catAx>
        <c:axId val="2960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Tomato paste samples compo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1461615"/>
        <c:crosses val="autoZero"/>
        <c:auto val="1"/>
        <c:lblAlgn val="ctr"/>
        <c:lblOffset val="100"/>
        <c:noMultiLvlLbl val="0"/>
      </c:catAx>
      <c:valAx>
        <c:axId val="1214616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/>
                  <a:t>Proportion of participant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60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60DC44-69B8-18C4-EB61-27F9199C48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DE5A49-A5AB-21BC-A3C1-34643CAA88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C844F1-C712-76EF-5BA4-5F5FDCA3F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6F5F9-BD08-C000-831A-215504B80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87649D-BFB1-1152-2D42-64DED194F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54408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85988C-0443-5673-8C2A-EE7AF28FB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48F773-2E1A-B2E5-ABC8-B6ACF45748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0E8543-0136-444E-FC23-DC7CB58B6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A030D7-DDD3-D4CB-1752-5909886D9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501389-24F6-8D13-9D88-A082A2F11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1300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4663BF-F81B-1861-3780-8E7B35BC87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5DCD01-0DE5-0302-C548-F64A20D20E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2BFC37-5453-76C7-4DBD-4382F3612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3A3DB0-7D31-45ED-7F71-E39DAC990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ADCAF-57DB-7920-AC03-7F0842AD5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6350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33AB0-13FE-B565-F7D6-835506CC6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810361-81F8-730C-808F-1155B8F7D0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46080-DC9A-E970-B9FA-E442EFA49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D0447A-0EEF-FBB6-D138-35525FEFC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ED3673-24D3-F0A5-23E9-4E9A81B34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2028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C6030-CE08-7358-2763-7097702B89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9CBD57-0B07-F784-EDA9-428709F29D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CAA8A-6F15-02A6-0693-E1DF5D058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E1DE8-D1FE-6BFA-F821-D5DD984C0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7C59D-7D3D-8156-9CB5-31920501C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3320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FA2F4-3633-95DB-44B1-726848F659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1967E5-7199-00F1-DDA7-A00BE3945D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735B77-B8C8-B62F-A3E1-7795E64298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6B7154-FB8C-D639-868E-3D04D773A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B2F12-115B-40DD-BA13-51D5F1318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7C7265-BF8C-33AC-ED11-C111C22BF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81582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3DA217-B2C9-FF9A-F542-152251DB93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E039DE-5B75-D65B-7466-AA2D730FD3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890AD8-BF10-F1FD-6A5D-FEA69E0087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22DDF6-FF54-E447-5489-4E11E4BF8B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95FCF8-1A45-52C3-CA34-86CD62BC88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2173F4-DCA2-C760-8DB7-8503E0E1B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D6DB43-4FBD-45AD-E86B-045B0918B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B67D6A-AA8E-7867-72A4-3BD4661EE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61997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77D33E-B5D7-674B-4030-2EDC0CEF9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D29632-8099-91D5-0904-39A34CAE9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20B1B6-6519-1715-46F8-238D144FC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A672A9-D26C-FF00-D5C4-8E2ED9A5A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8337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C9BAEF-5DFE-1145-D372-6D3466D32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73407C-F8E0-2FB1-D9DE-5442388AA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9AC855-3C16-7336-C606-BBF98DA13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0482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124D0-C0D5-6C64-71EB-11E8107AC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299162-B3B4-07C1-62D1-2D36CE7D3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42E6D-E6BA-0234-518A-F7036D740C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6C9439-09DC-66AB-6C26-803CC56FE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8D60FA-2E27-D951-820B-73964C173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BE8DD7-3D33-51A0-A41B-322542F65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0496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E445F-BE2C-1DE9-CCAA-7052B3EF7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BC936C-ECA0-B772-B65A-B35ED6752B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8D5074-EF2F-CD95-78EB-47BD7BDD17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0B41F5-AD78-0FEF-B999-382E8C732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8D1C10-5411-BF89-D555-31B452525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C87113-C006-2369-DFA4-AD30391E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3588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232E33-DCF1-5C13-6F78-E51FF8BCD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5B520-743A-7541-8FC3-29C6C4FF2F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2979AD-A376-10CC-A497-0A1FC1F968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92A45-038D-49AC-8D69-7E24059BC880}" type="datetimeFigureOut">
              <a:rPr lang="en-CA" smtClean="0"/>
              <a:t>2023-05-27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37B303-5247-D716-904B-B558DCB1F4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A08ABD-D9E6-744B-893D-2E72177B6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C1538-D9A8-4B4F-AD24-4285630BA9C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1394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B671A-2340-2D12-AA27-65EF0E8D6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dirty="0"/>
              <a:t>Annex 1. Taste ratings for tomato paste samples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D2739974-0426-6AAC-0403-69F7BB7B7C0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10326935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44706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B671A-2340-2D12-AA27-65EF0E8D6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dirty="0"/>
              <a:t>Annex 2. Color ratings for tomato paste samples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D2739974-0426-6AAC-0403-69F7BB7B7C00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97701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B671A-2340-2D12-AA27-65EF0E8D6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dirty="0"/>
              <a:t>Annex 3. Mouthfeel ratings for tomato paste samples</a:t>
            </a:r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154C8882-22D4-7777-EEEE-4D3AB0BE427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57218650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997473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B671A-2340-2D12-AA27-65EF0E8D6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dirty="0"/>
              <a:t>Annex 4. Texture/consistency ratings for tomato paste samples</a:t>
            </a:r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154C8882-22D4-7777-EEEE-4D3AB0BE427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13336850"/>
              </p:ext>
            </p:extLst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60839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70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Annex 1. Taste ratings for tomato paste samples</vt:lpstr>
      <vt:lpstr>Annex 2. Color ratings for tomato paste samples</vt:lpstr>
      <vt:lpstr>Annex 3. Mouthfeel ratings for tomato paste samples</vt:lpstr>
      <vt:lpstr>Annex 4. Texture/consistency ratings for tomato paste sampl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. Overall liking of tomato paste samples</dc:title>
  <dc:creator>Loloah Chamoun</dc:creator>
  <cp:lastModifiedBy>Loloah Chamoun</cp:lastModifiedBy>
  <cp:revision>1</cp:revision>
  <dcterms:created xsi:type="dcterms:W3CDTF">2023-05-27T13:26:25Z</dcterms:created>
  <dcterms:modified xsi:type="dcterms:W3CDTF">2023-05-27T13:53:55Z</dcterms:modified>
</cp:coreProperties>
</file>